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4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 descr="C:\Users\thinkpad\Desktop\博士课题\实验结果\实验结果\陈萍第三批实验结果\图片\Cp-1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4" y="548680"/>
            <a:ext cx="2520634" cy="1800000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</p:spPr>
      </p:pic>
      <p:pic>
        <p:nvPicPr>
          <p:cNvPr id="1032" name="Picture 8" descr="C:\Users\thinkpad\Desktop\博士课题\实验结果\实验结果\陈萍第三批实验结果\图片\Cp-17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987824" y="548680"/>
            <a:ext cx="2520634" cy="180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pic>
        <p:nvPicPr>
          <p:cNvPr id="1033" name="Picture 9" descr="C:\Users\thinkpad\Desktop\博士课题\实验结果\实验结果\陈萍第三批实验结果\图片\Cp-16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508104" y="548680"/>
            <a:ext cx="2520634" cy="18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graphicFrame>
        <p:nvGraphicFramePr>
          <p:cNvPr id="12" name="表格 11"/>
          <p:cNvGraphicFramePr>
            <a:graphicFrameLocks noGrp="1"/>
          </p:cNvGraphicFramePr>
          <p:nvPr/>
        </p:nvGraphicFramePr>
        <p:xfrm>
          <a:off x="1115616" y="2708920"/>
          <a:ext cx="6100304" cy="2734458"/>
        </p:xfrm>
        <a:graphic>
          <a:graphicData uri="http://schemas.openxmlformats.org/drawingml/2006/table">
            <a:tbl>
              <a:tblPr/>
              <a:tblGrid>
                <a:gridCol w="139314"/>
                <a:gridCol w="523162"/>
                <a:gridCol w="448801"/>
                <a:gridCol w="601215"/>
                <a:gridCol w="425597"/>
                <a:gridCol w="396591"/>
                <a:gridCol w="448801"/>
                <a:gridCol w="523162"/>
                <a:gridCol w="523162"/>
                <a:gridCol w="510505"/>
                <a:gridCol w="513142"/>
                <a:gridCol w="546367"/>
                <a:gridCol w="500485"/>
              </a:tblGrid>
              <a:tr h="14555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 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A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B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C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D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E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F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H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I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J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K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0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L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314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1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1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2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3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3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Ligand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-CSF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IT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M-CSF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FN- gamma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314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2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1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2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3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3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Ligand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-CSF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IT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M-CSF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FN-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amma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50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3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</a:t>
                      </a:r>
                      <a:r>
                        <a:rPr lang="en-US" sz="800" b="1" kern="100" dirty="0" err="1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sRI</a:t>
                      </a: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 </a:t>
                      </a:r>
                      <a:endParaRPr lang="zh-CN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sRII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4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7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3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A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F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β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50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4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sRI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sRII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40 </a:t>
                      </a:r>
                      <a:endParaRPr lang="zh-CN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7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3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A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F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β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314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5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2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3  p19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8A </a:t>
                      </a:r>
                      <a:endParaRPr lang="zh-CN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4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5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s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MIP-3α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sgp13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1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3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314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6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2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3  p19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8A </a:t>
                      </a:r>
                      <a:endParaRPr lang="zh-CN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4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5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sR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MIP-3α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sgp130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1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3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97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7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α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β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RANCE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9714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7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8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α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β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RANCE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0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188640"/>
            <a:ext cx="7848872" cy="63367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pic>
        <p:nvPicPr>
          <p:cNvPr id="6" name="Picture 7" descr="C:\Users\thinkpad\Desktop\博士课题\实验结果\实验结果\陈萍第三批实验结果\图片\Cp-1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4" y="548680"/>
            <a:ext cx="2520634" cy="1800000"/>
          </a:xfrm>
          <a:prstGeom prst="rect">
            <a:avLst/>
          </a:prstGeom>
          <a:noFill/>
          <a:ln w="12700" cmpd="sng">
            <a:solidFill>
              <a:schemeClr val="tx1"/>
            </a:solidFill>
          </a:ln>
        </p:spPr>
      </p:pic>
      <p:pic>
        <p:nvPicPr>
          <p:cNvPr id="7" name="Picture 8" descr="C:\Users\thinkpad\Desktop\博士课题\实验结果\实验结果\陈萍第三批实验结果\图片\Cp-17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987824" y="548680"/>
            <a:ext cx="2520634" cy="1800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pic>
        <p:nvPicPr>
          <p:cNvPr id="8" name="Picture 9" descr="C:\Users\thinkpad\Desktop\博士课题\实验结果\实验结果\陈萍第三批实验结果\图片\Cp-16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508104" y="548680"/>
            <a:ext cx="2520634" cy="18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graphicFrame>
        <p:nvGraphicFramePr>
          <p:cNvPr id="9" name="表格 8"/>
          <p:cNvGraphicFramePr>
            <a:graphicFrameLocks noGrp="1"/>
          </p:cNvGraphicFramePr>
          <p:nvPr/>
        </p:nvGraphicFramePr>
        <p:xfrm>
          <a:off x="467544" y="2708920"/>
          <a:ext cx="7560838" cy="3672406"/>
        </p:xfrm>
        <a:graphic>
          <a:graphicData uri="http://schemas.openxmlformats.org/drawingml/2006/table">
            <a:tbl>
              <a:tblPr/>
              <a:tblGrid>
                <a:gridCol w="172668"/>
                <a:gridCol w="648417"/>
                <a:gridCol w="556253"/>
                <a:gridCol w="745158"/>
                <a:gridCol w="527494"/>
                <a:gridCol w="491543"/>
                <a:gridCol w="556253"/>
                <a:gridCol w="648417"/>
                <a:gridCol w="648417"/>
                <a:gridCol w="632730"/>
                <a:gridCol w="635998"/>
                <a:gridCol w="677178"/>
                <a:gridCol w="620312"/>
              </a:tblGrid>
              <a:tr h="190386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 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A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B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C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D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E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F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H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I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J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K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L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820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1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1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2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3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3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Ligand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-CSF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IT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M-CSF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FN- gamma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820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2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1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2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POS3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3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Ligand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CD4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-CSF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IT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M-CSF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FN-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gamma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230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3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</a:t>
                      </a:r>
                      <a:r>
                        <a:rPr lang="en-US" sz="1100" b="1" kern="100" dirty="0" err="1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sRI</a:t>
                      </a: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sRII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4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7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3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A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F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β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230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4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sRI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sRII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40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2 p7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3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A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F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7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1 β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820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5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2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3  p19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8A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4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5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s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MIP-3α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sgp13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1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3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820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6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1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2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3  p19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28A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4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5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IL-6 sR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MIP-3α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sgp130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1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GF-β3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230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7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α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β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RANCE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2303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100">
                          <a:solidFill>
                            <a:srgbClr val="000000"/>
                          </a:solidFill>
                          <a:latin typeface="Microsoft Sans Serif"/>
                          <a:ea typeface="宋体"/>
                          <a:cs typeface="Trebuchet MS"/>
                        </a:rPr>
                        <a:t>8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α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NF-β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TRANCE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en-US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100" dirty="0">
                          <a:solidFill>
                            <a:srgbClr val="000000"/>
                          </a:solidFill>
                          <a:latin typeface="Arial"/>
                          <a:ea typeface="宋体"/>
                          <a:cs typeface="Trebuchet MS"/>
                        </a:rPr>
                        <a:t>NEG </a:t>
                      </a:r>
                      <a:endParaRPr lang="zh-CN" sz="1100" kern="100" dirty="0">
                        <a:solidFill>
                          <a:srgbClr val="000000"/>
                        </a:solidFill>
                        <a:latin typeface="Trebuchet MS"/>
                        <a:ea typeface="宋体"/>
                        <a:cs typeface="Trebuchet MS"/>
                      </a:endParaRPr>
                    </a:p>
                  </a:txBody>
                  <a:tcPr marL="56957" marR="569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467544" y="188640"/>
            <a:ext cx="3080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/>
              <a:t>a</a:t>
            </a:r>
            <a:endParaRPr lang="zh-CN" altLang="en-US" sz="2000" dirty="0"/>
          </a:p>
        </p:txBody>
      </p:sp>
      <p:sp>
        <p:nvSpPr>
          <p:cNvPr id="11" name="TextBox 10"/>
          <p:cNvSpPr txBox="1"/>
          <p:nvPr/>
        </p:nvSpPr>
        <p:spPr>
          <a:xfrm>
            <a:off x="467544" y="2348880"/>
            <a:ext cx="3193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/>
              <a:t>d</a:t>
            </a:r>
            <a:endParaRPr lang="zh-CN" altLang="en-US" sz="2000" dirty="0"/>
          </a:p>
        </p:txBody>
      </p:sp>
      <p:sp>
        <p:nvSpPr>
          <p:cNvPr id="12" name="TextBox 11"/>
          <p:cNvSpPr txBox="1"/>
          <p:nvPr/>
        </p:nvSpPr>
        <p:spPr>
          <a:xfrm>
            <a:off x="5508104" y="188640"/>
            <a:ext cx="2936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/>
              <a:t>c</a:t>
            </a:r>
            <a:endParaRPr lang="zh-CN" altLang="en-US" sz="2000" dirty="0"/>
          </a:p>
        </p:txBody>
      </p:sp>
      <p:sp>
        <p:nvSpPr>
          <p:cNvPr id="13" name="TextBox 12"/>
          <p:cNvSpPr txBox="1"/>
          <p:nvPr/>
        </p:nvSpPr>
        <p:spPr>
          <a:xfrm>
            <a:off x="3059832" y="188640"/>
            <a:ext cx="3193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 smtClean="0"/>
              <a:t>b</a:t>
            </a:r>
            <a:endParaRPr lang="zh-CN" altLang="en-US" sz="2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4</Words>
  <Application>Microsoft Office PowerPoint</Application>
  <PresentationFormat>全屏显示(4:3)</PresentationFormat>
  <Paragraphs>344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Ping Chen</dc:creator>
  <cp:lastModifiedBy>thinkpad</cp:lastModifiedBy>
  <cp:revision>2</cp:revision>
  <dcterms:created xsi:type="dcterms:W3CDTF">2018-10-02T11:21:01Z</dcterms:created>
  <dcterms:modified xsi:type="dcterms:W3CDTF">2019-04-20T14:44:26Z</dcterms:modified>
</cp:coreProperties>
</file>